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9281"/>
    <p:restoredTop sz="94648"/>
  </p:normalViewPr>
  <p:slideViewPr>
    <p:cSldViewPr snapToGrid="0">
      <p:cViewPr varScale="1">
        <p:scale>
          <a:sx n="112" d="100"/>
          <a:sy n="112" d="100"/>
        </p:scale>
        <p:origin x="216" y="28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973DF1BD-2231-E70F-8825-11C60514091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Untertitel 2">
            <a:extLst>
              <a:ext uri="{FF2B5EF4-FFF2-40B4-BE49-F238E27FC236}">
                <a16:creationId xmlns:a16="http://schemas.microsoft.com/office/drawing/2014/main" id="{6F2771FA-8633-3187-7392-E6DAF035E35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/>
              <a:t>Master-Untertitel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440BFC8C-6348-72AD-CA87-A37D252F2B0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C0FF52-27AB-F042-BCC7-F4A928E72F28}" type="datetimeFigureOut">
              <a:rPr lang="de-DE" smtClean="0"/>
              <a:t>26.02.25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1818A985-4123-DB46-B822-CF8C99A3A19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10FF3ABE-6F77-EE10-C431-A1969528C16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AE2266-6906-C84C-BF47-7400595BCE9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5378449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06F1F0A2-3D54-0CBA-48A7-FBE64A564EC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68D98CC0-F406-4693-C0C9-3EB2B397881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52C7D098-3734-D303-C7DC-511D68C0915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C0FF52-27AB-F042-BCC7-F4A928E72F28}" type="datetimeFigureOut">
              <a:rPr lang="de-DE" smtClean="0"/>
              <a:t>26.02.25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056CF025-FFB9-8407-4FE3-D0E5DEB3CF7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AD53A6CC-E835-77B2-C388-8C61B6DB8FA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AE2266-6906-C84C-BF47-7400595BCE9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90316372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>
            <a:extLst>
              <a:ext uri="{FF2B5EF4-FFF2-40B4-BE49-F238E27FC236}">
                <a16:creationId xmlns:a16="http://schemas.microsoft.com/office/drawing/2014/main" id="{A8A2BC9B-7DBF-87CA-A044-21559F6DFD6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42EB37BE-E90E-CC00-FE5B-946C8F6D9E5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83B03EA2-AF88-044C-84F9-94AC89114DF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C0FF52-27AB-F042-BCC7-F4A928E72F28}" type="datetimeFigureOut">
              <a:rPr lang="de-DE" smtClean="0"/>
              <a:t>26.02.25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BB8A5C01-AC70-F19C-7B5C-7C21108BA23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230B7443-D985-00AB-D312-930681B6221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AE2266-6906-C84C-BF47-7400595BCE9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18751097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12D5B930-EF8E-A71F-1A0C-861EB81E1F6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4CD00352-D7E6-857A-EF50-13CCD5AA03B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3B5C6689-097F-28C2-2E6C-6C635D380EB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C0FF52-27AB-F042-BCC7-F4A928E72F28}" type="datetimeFigureOut">
              <a:rPr lang="de-DE" smtClean="0"/>
              <a:t>26.02.25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EC472C9F-A6BE-5330-E200-D977D53A7E9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8FFC4A47-86C7-0ACF-C1AB-09B4FC83659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AE2266-6906-C84C-BF47-7400595BCE9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69924752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69E10952-F41D-A97D-CE68-CBC6D6C2984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D736BD7A-0054-9436-2C51-9229C693852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AA0E61C3-554E-5FBA-0B51-EDE14CF4F3F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C0FF52-27AB-F042-BCC7-F4A928E72F28}" type="datetimeFigureOut">
              <a:rPr lang="de-DE" smtClean="0"/>
              <a:t>26.02.25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6E0045BD-7AD9-0BF1-73F6-FE7782898C7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4981A311-A2F1-816C-C22A-6238E48E828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AE2266-6906-C84C-BF47-7400595BCE9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11217892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0E9EC423-E455-E4F3-F359-500999D3C9A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C4D794B9-DE4E-B5A7-0128-3C4BAB82E86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F2B237BD-2C17-EFA1-4423-6061A10A26D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5FBE57C5-54D5-6886-37FC-0CFB54F607D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C0FF52-27AB-F042-BCC7-F4A928E72F28}" type="datetimeFigureOut">
              <a:rPr lang="de-DE" smtClean="0"/>
              <a:t>26.02.25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DDE233DF-A42F-DD61-3968-AE365B9FF15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AA3551E9-306E-6002-C25F-CD98339190A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AE2266-6906-C84C-BF47-7400595BCE9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53970224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4411F2F5-FA0F-EC10-220F-65C247121D6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FACC1A8D-0FFE-487C-CFAE-BA0DA7EAE02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B1537E77-1137-C441-9E5B-5F3B4BF7063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>
            <a:extLst>
              <a:ext uri="{FF2B5EF4-FFF2-40B4-BE49-F238E27FC236}">
                <a16:creationId xmlns:a16="http://schemas.microsoft.com/office/drawing/2014/main" id="{D9B8F618-2D4F-1120-3E8B-FA314973A6E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Inhaltsplatzhalter 5">
            <a:extLst>
              <a:ext uri="{FF2B5EF4-FFF2-40B4-BE49-F238E27FC236}">
                <a16:creationId xmlns:a16="http://schemas.microsoft.com/office/drawing/2014/main" id="{FCC42FD9-D646-2D82-C2A7-D901F6F721A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>
            <a:extLst>
              <a:ext uri="{FF2B5EF4-FFF2-40B4-BE49-F238E27FC236}">
                <a16:creationId xmlns:a16="http://schemas.microsoft.com/office/drawing/2014/main" id="{3B9F9E8C-6DB8-9F65-BA0E-0796F0B76B2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C0FF52-27AB-F042-BCC7-F4A928E72F28}" type="datetimeFigureOut">
              <a:rPr lang="de-DE" smtClean="0"/>
              <a:t>26.02.25</a:t>
            </a:fld>
            <a:endParaRPr lang="de-DE"/>
          </a:p>
        </p:txBody>
      </p:sp>
      <p:sp>
        <p:nvSpPr>
          <p:cNvPr id="8" name="Fußzeilenplatzhalter 7">
            <a:extLst>
              <a:ext uri="{FF2B5EF4-FFF2-40B4-BE49-F238E27FC236}">
                <a16:creationId xmlns:a16="http://schemas.microsoft.com/office/drawing/2014/main" id="{34E84E08-FC09-44A3-7FFC-E81D5F92256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>
            <a:extLst>
              <a:ext uri="{FF2B5EF4-FFF2-40B4-BE49-F238E27FC236}">
                <a16:creationId xmlns:a16="http://schemas.microsoft.com/office/drawing/2014/main" id="{53E9506E-F47F-02AB-4BBE-6C23F8F8E41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AE2266-6906-C84C-BF47-7400595BCE9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01462704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CD292887-946A-29B5-FC00-DB9451465FC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Datumsplatzhalter 2">
            <a:extLst>
              <a:ext uri="{FF2B5EF4-FFF2-40B4-BE49-F238E27FC236}">
                <a16:creationId xmlns:a16="http://schemas.microsoft.com/office/drawing/2014/main" id="{890FD604-7035-0622-D6AC-08A8ACCD634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C0FF52-27AB-F042-BCC7-F4A928E72F28}" type="datetimeFigureOut">
              <a:rPr lang="de-DE" smtClean="0"/>
              <a:t>26.02.25</a:t>
            </a:fld>
            <a:endParaRPr lang="de-DE"/>
          </a:p>
        </p:txBody>
      </p:sp>
      <p:sp>
        <p:nvSpPr>
          <p:cNvPr id="4" name="Fußzeilenplatzhalter 3">
            <a:extLst>
              <a:ext uri="{FF2B5EF4-FFF2-40B4-BE49-F238E27FC236}">
                <a16:creationId xmlns:a16="http://schemas.microsoft.com/office/drawing/2014/main" id="{B06B02CB-17E3-E976-8979-8073EB1CB82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>
            <a:extLst>
              <a:ext uri="{FF2B5EF4-FFF2-40B4-BE49-F238E27FC236}">
                <a16:creationId xmlns:a16="http://schemas.microsoft.com/office/drawing/2014/main" id="{6DCE7C94-D0D6-0924-FBC4-255263D8512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AE2266-6906-C84C-BF47-7400595BCE9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74321060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>
            <a:extLst>
              <a:ext uri="{FF2B5EF4-FFF2-40B4-BE49-F238E27FC236}">
                <a16:creationId xmlns:a16="http://schemas.microsoft.com/office/drawing/2014/main" id="{A11A8690-C858-7BF2-96D4-531CE1F394F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C0FF52-27AB-F042-BCC7-F4A928E72F28}" type="datetimeFigureOut">
              <a:rPr lang="de-DE" smtClean="0"/>
              <a:t>26.02.25</a:t>
            </a:fld>
            <a:endParaRPr lang="de-DE"/>
          </a:p>
        </p:txBody>
      </p:sp>
      <p:sp>
        <p:nvSpPr>
          <p:cNvPr id="3" name="Fußzeilenplatzhalter 2">
            <a:extLst>
              <a:ext uri="{FF2B5EF4-FFF2-40B4-BE49-F238E27FC236}">
                <a16:creationId xmlns:a16="http://schemas.microsoft.com/office/drawing/2014/main" id="{C23A723B-4AE0-A5DD-E8DD-812339A2FFE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>
            <a:extLst>
              <a:ext uri="{FF2B5EF4-FFF2-40B4-BE49-F238E27FC236}">
                <a16:creationId xmlns:a16="http://schemas.microsoft.com/office/drawing/2014/main" id="{E81D8E93-E1D2-D4A1-8C08-3CB8543D564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AE2266-6906-C84C-BF47-7400595BCE9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8007253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5187E05B-844E-4B0B-94E0-4C7082AD2BB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54B8819A-4A6B-AA67-F226-E96D15DDBCA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6D9067A1-7CBF-FDA9-19A6-91E8CF50028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67746286-E19E-2B68-F3BD-4CFF8B46CE0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C0FF52-27AB-F042-BCC7-F4A928E72F28}" type="datetimeFigureOut">
              <a:rPr lang="de-DE" smtClean="0"/>
              <a:t>26.02.25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4135A734-7764-A887-5066-73154A00F3B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91E5891E-71B4-2F7E-AD6D-9AE738317D7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AE2266-6906-C84C-BF47-7400595BCE9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9669998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E49541A9-AD88-CEFF-3298-A268FEA89A8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Bildplatzhalter 2">
            <a:extLst>
              <a:ext uri="{FF2B5EF4-FFF2-40B4-BE49-F238E27FC236}">
                <a16:creationId xmlns:a16="http://schemas.microsoft.com/office/drawing/2014/main" id="{4142ADF4-E076-BCEC-68B8-D85D6828D84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86956BAE-5D01-0007-18B6-10EAFDCB75A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14334B9E-0F24-F237-4FCF-1077B761121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C0FF52-27AB-F042-BCC7-F4A928E72F28}" type="datetimeFigureOut">
              <a:rPr lang="de-DE" smtClean="0"/>
              <a:t>26.02.25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BE99B8D2-9BD7-7681-E431-00426F964E3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B7F580E9-2469-9ED3-CB0C-4A898783E4F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AE2266-6906-C84C-BF47-7400595BCE9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47971645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>
            <a:extLst>
              <a:ext uri="{FF2B5EF4-FFF2-40B4-BE49-F238E27FC236}">
                <a16:creationId xmlns:a16="http://schemas.microsoft.com/office/drawing/2014/main" id="{2A576D58-0A5F-CEE5-8F8D-CD4A3837F9E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7DABFD03-22F5-C84F-3C67-C8B58A9C067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4C14A7DF-7272-785F-F38D-E5B28F9C91C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EEC0FF52-27AB-F042-BCC7-F4A928E72F28}" type="datetimeFigureOut">
              <a:rPr lang="de-DE" smtClean="0"/>
              <a:t>26.02.25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43926BF8-4C59-63A9-6B93-E697299B776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E8E226FD-1E39-D536-192F-58CCBA4D149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15AE2266-6906-C84C-BF47-7400595BCE9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14247724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Grafik 4" descr="Ein Bild, das Karte, Screenshot enthält.&#10;&#10;Automatisch generierte Beschreibung">
            <a:extLst>
              <a:ext uri="{FF2B5EF4-FFF2-40B4-BE49-F238E27FC236}">
                <a16:creationId xmlns:a16="http://schemas.microsoft.com/office/drawing/2014/main" id="{3668F6AA-DE31-9453-585F-4E991620545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59269" y="716228"/>
            <a:ext cx="4626297" cy="2392912"/>
          </a:xfrm>
          <a:prstGeom prst="rect">
            <a:avLst/>
          </a:prstGeom>
          <a:ln w="9525">
            <a:noFill/>
          </a:ln>
        </p:spPr>
      </p:pic>
      <p:pic>
        <p:nvPicPr>
          <p:cNvPr id="9" name="Grafik 8" descr="Ein Bild, das Karte, Screenshot enthält.&#10;&#10;Automatisch generierte Beschreibung">
            <a:extLst>
              <a:ext uri="{FF2B5EF4-FFF2-40B4-BE49-F238E27FC236}">
                <a16:creationId xmlns:a16="http://schemas.microsoft.com/office/drawing/2014/main" id="{880950B0-3FD2-45EF-B3E8-77E7B4FFF5F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844284" y="646401"/>
            <a:ext cx="4711846" cy="2434453"/>
          </a:xfrm>
          <a:prstGeom prst="rect">
            <a:avLst/>
          </a:prstGeom>
          <a:ln w="9525">
            <a:noFill/>
          </a:ln>
        </p:spPr>
      </p:pic>
      <p:sp>
        <p:nvSpPr>
          <p:cNvPr id="13" name="Textfeld 12">
            <a:extLst>
              <a:ext uri="{FF2B5EF4-FFF2-40B4-BE49-F238E27FC236}">
                <a16:creationId xmlns:a16="http://schemas.microsoft.com/office/drawing/2014/main" id="{481BF375-F2E4-96F8-78BA-6A1FFCEFDFDC}"/>
              </a:ext>
            </a:extLst>
          </p:cNvPr>
          <p:cNvSpPr txBox="1"/>
          <p:nvPr/>
        </p:nvSpPr>
        <p:spPr>
          <a:xfrm>
            <a:off x="209037" y="679603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b="1" dirty="0"/>
              <a:t>a</a:t>
            </a:r>
          </a:p>
        </p:txBody>
      </p:sp>
      <p:sp>
        <p:nvSpPr>
          <p:cNvPr id="18" name="Textfeld 17">
            <a:extLst>
              <a:ext uri="{FF2B5EF4-FFF2-40B4-BE49-F238E27FC236}">
                <a16:creationId xmlns:a16="http://schemas.microsoft.com/office/drawing/2014/main" id="{EA6B8D5D-1ED5-11F9-EA6B-7EE5ACE287E7}"/>
              </a:ext>
            </a:extLst>
          </p:cNvPr>
          <p:cNvSpPr txBox="1"/>
          <p:nvPr/>
        </p:nvSpPr>
        <p:spPr>
          <a:xfrm>
            <a:off x="5768872" y="716228"/>
            <a:ext cx="29046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b="1" dirty="0"/>
              <a:t>b</a:t>
            </a:r>
          </a:p>
        </p:txBody>
      </p:sp>
      <p:sp>
        <p:nvSpPr>
          <p:cNvPr id="20" name="Textfeld 19">
            <a:extLst>
              <a:ext uri="{FF2B5EF4-FFF2-40B4-BE49-F238E27FC236}">
                <a16:creationId xmlns:a16="http://schemas.microsoft.com/office/drawing/2014/main" id="{03AEE2AF-2007-930D-BC16-30B275C56192}"/>
              </a:ext>
            </a:extLst>
          </p:cNvPr>
          <p:cNvSpPr txBox="1"/>
          <p:nvPr/>
        </p:nvSpPr>
        <p:spPr>
          <a:xfrm>
            <a:off x="246948" y="3111429"/>
            <a:ext cx="195598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a. a</a:t>
            </a:r>
            <a:r>
              <a:rPr lang="de-DE" sz="1100">
                <a:latin typeface="Arial" panose="020B0604020202020204" pitchFamily="34" charset="0"/>
                <a:cs typeface="Arial" panose="020B0604020202020204" pitchFamily="34" charset="0"/>
              </a:rPr>
              <a:t>nti-CD117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stained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tissue</a:t>
            </a:r>
            <a:endParaRPr lang="de-DE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feld 20">
            <a:extLst>
              <a:ext uri="{FF2B5EF4-FFF2-40B4-BE49-F238E27FC236}">
                <a16:creationId xmlns:a16="http://schemas.microsoft.com/office/drawing/2014/main" id="{DC41F628-B225-73C0-F811-75CA0CADDA08}"/>
              </a:ext>
            </a:extLst>
          </p:cNvPr>
          <p:cNvSpPr txBox="1"/>
          <p:nvPr/>
        </p:nvSpPr>
        <p:spPr>
          <a:xfrm>
            <a:off x="146051" y="355065"/>
            <a:ext cx="591328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Figure 6: Mast </a:t>
            </a:r>
            <a:r>
              <a:rPr lang="de-DE" sz="1400" dirty="0" err="1">
                <a:latin typeface="Arial" panose="020B0604020202020204" pitchFamily="34" charset="0"/>
                <a:cs typeface="Arial" panose="020B0604020202020204" pitchFamily="34" charset="0"/>
              </a:rPr>
              <a:t>cells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dirty="0" err="1">
                <a:latin typeface="Arial" panose="020B0604020202020204" pitchFamily="34" charset="0"/>
                <a:cs typeface="Arial" panose="020B0604020202020204" pitchFamily="34" charset="0"/>
              </a:rPr>
              <a:t>stained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dirty="0" err="1">
                <a:latin typeface="Arial" panose="020B0604020202020204" pitchFamily="34" charset="0"/>
                <a:cs typeface="Arial" panose="020B0604020202020204" pitchFamily="34" charset="0"/>
              </a:rPr>
              <a:t>with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 anti-CD117 and </a:t>
            </a:r>
            <a:r>
              <a:rPr lang="de-DE" sz="1400" dirty="0" err="1">
                <a:latin typeface="Arial" panose="020B0604020202020204" pitchFamily="34" charset="0"/>
                <a:cs typeface="Arial" panose="020B0604020202020204" pitchFamily="34" charset="0"/>
              </a:rPr>
              <a:t>detection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dirty="0" err="1">
                <a:latin typeface="Arial" panose="020B0604020202020204" pitchFamily="34" charset="0"/>
                <a:cs typeface="Arial" panose="020B0604020202020204" pitchFamily="34" charset="0"/>
              </a:rPr>
              <a:t>with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4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MIKAIA</a:t>
            </a:r>
            <a:r>
              <a:rPr lang="en-US" sz="14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®</a:t>
            </a:r>
            <a:endParaRPr lang="de-DE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feld 21">
            <a:extLst>
              <a:ext uri="{FF2B5EF4-FFF2-40B4-BE49-F238E27FC236}">
                <a16:creationId xmlns:a16="http://schemas.microsoft.com/office/drawing/2014/main" id="{35624101-BA5F-001A-6918-73CA3A65749C}"/>
              </a:ext>
            </a:extLst>
          </p:cNvPr>
          <p:cNvSpPr txBox="1"/>
          <p:nvPr/>
        </p:nvSpPr>
        <p:spPr>
          <a:xfrm>
            <a:off x="5844284" y="3092988"/>
            <a:ext cx="3404946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b. 10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mast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cells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marked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in a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purple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hotspot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diameter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200 µm)</a:t>
            </a:r>
          </a:p>
        </p:txBody>
      </p:sp>
      <p:sp>
        <p:nvSpPr>
          <p:cNvPr id="2" name="Rechteck 1">
            <a:extLst>
              <a:ext uri="{FF2B5EF4-FFF2-40B4-BE49-F238E27FC236}">
                <a16:creationId xmlns:a16="http://schemas.microsoft.com/office/drawing/2014/main" id="{08428326-3ED7-B432-D9C6-5200B841C087}"/>
              </a:ext>
            </a:extLst>
          </p:cNvPr>
          <p:cNvSpPr/>
          <p:nvPr/>
        </p:nvSpPr>
        <p:spPr>
          <a:xfrm>
            <a:off x="3014697" y="2152714"/>
            <a:ext cx="1065813" cy="444321"/>
          </a:xfrm>
          <a:prstGeom prst="rect">
            <a:avLst/>
          </a:prstGeom>
          <a:noFill/>
          <a:ln w="15875"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cxnSp>
        <p:nvCxnSpPr>
          <p:cNvPr id="4" name="Gerade Verbindung mit Pfeil 3">
            <a:extLst>
              <a:ext uri="{FF2B5EF4-FFF2-40B4-BE49-F238E27FC236}">
                <a16:creationId xmlns:a16="http://schemas.microsoft.com/office/drawing/2014/main" id="{1116D654-2BB5-DB6C-827B-25A6B4F63F57}"/>
              </a:ext>
            </a:extLst>
          </p:cNvPr>
          <p:cNvCxnSpPr>
            <a:cxnSpLocks/>
            <a:stCxn id="2" idx="3"/>
          </p:cNvCxnSpPr>
          <p:nvPr/>
        </p:nvCxnSpPr>
        <p:spPr>
          <a:xfrm>
            <a:off x="4080510" y="2374875"/>
            <a:ext cx="669669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pic>
        <p:nvPicPr>
          <p:cNvPr id="6" name="Grafik 5">
            <a:extLst>
              <a:ext uri="{FF2B5EF4-FFF2-40B4-BE49-F238E27FC236}">
                <a16:creationId xmlns:a16="http://schemas.microsoft.com/office/drawing/2014/main" id="{E1A74DD3-AE57-1D57-1376-7931FA97C1FA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r="13855"/>
          <a:stretch/>
        </p:blipFill>
        <p:spPr>
          <a:xfrm>
            <a:off x="246948" y="3523875"/>
            <a:ext cx="4626296" cy="2418786"/>
          </a:xfrm>
          <a:prstGeom prst="rect">
            <a:avLst/>
          </a:prstGeom>
          <a:ln w="9525">
            <a:noFill/>
          </a:ln>
        </p:spPr>
      </p:pic>
      <p:sp>
        <p:nvSpPr>
          <p:cNvPr id="10" name="Textfeld 9">
            <a:extLst>
              <a:ext uri="{FF2B5EF4-FFF2-40B4-BE49-F238E27FC236}">
                <a16:creationId xmlns:a16="http://schemas.microsoft.com/office/drawing/2014/main" id="{84825056-40D6-3480-A351-0BDCCE80EA7E}"/>
              </a:ext>
            </a:extLst>
          </p:cNvPr>
          <p:cNvSpPr txBox="1"/>
          <p:nvPr/>
        </p:nvSpPr>
        <p:spPr>
          <a:xfrm>
            <a:off x="176488" y="6051399"/>
            <a:ext cx="6096000" cy="76944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c. an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overview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after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detection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with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1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MIKAIA</a:t>
            </a:r>
            <a:r>
              <a:rPr lang="en-US" sz="11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® 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on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another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slide</a:t>
            </a:r>
            <a:endParaRPr lang="de-DE" sz="11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285750" indent="-285750">
              <a:buFontTx/>
              <a:buChar char="-"/>
            </a:pP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green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line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for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tissue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detection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  <a:p>
            <a:pPr marL="285750" indent="-285750">
              <a:buFontTx/>
              <a:buChar char="-"/>
            </a:pP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red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circle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marked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mast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cells</a:t>
            </a:r>
            <a:endParaRPr lang="de-DE" sz="11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285750" indent="-285750">
              <a:buFontTx/>
              <a:buChar char="-"/>
            </a:pP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purple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circle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marked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hotspots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with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a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diameter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200 µm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each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  <p:sp>
        <p:nvSpPr>
          <p:cNvPr id="12" name="Textfeld 11">
            <a:extLst>
              <a:ext uri="{FF2B5EF4-FFF2-40B4-BE49-F238E27FC236}">
                <a16:creationId xmlns:a16="http://schemas.microsoft.com/office/drawing/2014/main" id="{FB45C50C-119B-F7C8-8E24-E470DF12E653}"/>
              </a:ext>
            </a:extLst>
          </p:cNvPr>
          <p:cNvSpPr txBox="1"/>
          <p:nvPr/>
        </p:nvSpPr>
        <p:spPr>
          <a:xfrm>
            <a:off x="256356" y="3473782"/>
            <a:ext cx="28245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b="1" dirty="0"/>
              <a:t>c</a:t>
            </a:r>
          </a:p>
        </p:txBody>
      </p:sp>
      <p:sp>
        <p:nvSpPr>
          <p:cNvPr id="3" name="Textfeld 2">
            <a:extLst>
              <a:ext uri="{FF2B5EF4-FFF2-40B4-BE49-F238E27FC236}">
                <a16:creationId xmlns:a16="http://schemas.microsoft.com/office/drawing/2014/main" id="{74B7FB78-E3CA-8BF4-52BF-7D3F2A527488}"/>
              </a:ext>
            </a:extLst>
          </p:cNvPr>
          <p:cNvSpPr txBox="1"/>
          <p:nvPr/>
        </p:nvSpPr>
        <p:spPr>
          <a:xfrm>
            <a:off x="248283" y="2873017"/>
            <a:ext cx="584614" cy="23612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endParaRPr lang="de-DE" dirty="0"/>
          </a:p>
        </p:txBody>
      </p:sp>
      <p:sp>
        <p:nvSpPr>
          <p:cNvPr id="11" name="Textfeld 10">
            <a:extLst>
              <a:ext uri="{FF2B5EF4-FFF2-40B4-BE49-F238E27FC236}">
                <a16:creationId xmlns:a16="http://schemas.microsoft.com/office/drawing/2014/main" id="{8BF352CF-8525-E17E-AAC0-2270B9548002}"/>
              </a:ext>
            </a:extLst>
          </p:cNvPr>
          <p:cNvSpPr txBox="1"/>
          <p:nvPr/>
        </p:nvSpPr>
        <p:spPr>
          <a:xfrm>
            <a:off x="5844284" y="2852087"/>
            <a:ext cx="584614" cy="23612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endParaRPr lang="de-DE" dirty="0"/>
          </a:p>
        </p:txBody>
      </p:sp>
      <p:sp>
        <p:nvSpPr>
          <p:cNvPr id="14" name="Textfeld 13">
            <a:extLst>
              <a:ext uri="{FF2B5EF4-FFF2-40B4-BE49-F238E27FC236}">
                <a16:creationId xmlns:a16="http://schemas.microsoft.com/office/drawing/2014/main" id="{58BEC597-295B-2CDC-13BF-535F1FBF3373}"/>
              </a:ext>
            </a:extLst>
          </p:cNvPr>
          <p:cNvSpPr txBox="1"/>
          <p:nvPr/>
        </p:nvSpPr>
        <p:spPr>
          <a:xfrm>
            <a:off x="245455" y="5706739"/>
            <a:ext cx="744680" cy="23635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103700714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69</Words>
  <Application>Microsoft Macintosh PowerPoint</Application>
  <PresentationFormat>Breitbild</PresentationFormat>
  <Paragraphs>10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</vt:lpstr>
      <vt:lpstr>PowerPoint-Prä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Hironimus, Theresa</dc:creator>
  <cp:lastModifiedBy>Hironimus, Theresa</cp:lastModifiedBy>
  <cp:revision>40</cp:revision>
  <dcterms:created xsi:type="dcterms:W3CDTF">2024-05-14T06:09:16Z</dcterms:created>
  <dcterms:modified xsi:type="dcterms:W3CDTF">2025-02-26T18:59:02Z</dcterms:modified>
</cp:coreProperties>
</file>